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4" r:id="rId5"/>
    <p:sldId id="266" r:id="rId6"/>
    <p:sldId id="260" r:id="rId7"/>
    <p:sldId id="258" r:id="rId8"/>
    <p:sldId id="265" r:id="rId9"/>
    <p:sldId id="262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B4A466-C6DB-467A-B0ED-C8B07A2BA4E7}" v="23" dt="2022-07-06T13:53:36.237"/>
    <p1510:client id="{24D326B1-2337-4274-BE59-5622B006B2B3}" v="14" dt="2022-07-07T01:53:17.489"/>
    <p1510:client id="{4473A940-9468-4EB7-A44C-70C1191C90E6}" v="28" dt="2022-07-06T14:05:47.224"/>
    <p1510:client id="{A2FE8121-67BB-432F-AD11-861EAA644E4F}" v="141" dt="2022-07-06T13:32:09.721"/>
    <p1510:client id="{AA6FAF9A-D400-486E-B2A7-23FA94FC5542}" v="16" dt="2022-07-08T01:32:50.33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30"/>
    <p:restoredTop sz="94680"/>
  </p:normalViewPr>
  <p:slideViewPr>
    <p:cSldViewPr snapToGrid="0" snapToObjects="1">
      <p:cViewPr varScale="1">
        <p:scale>
          <a:sx n="110" d="100"/>
          <a:sy n="110" d="100"/>
        </p:scale>
        <p:origin x="176" y="2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황미영" userId="S::myhwang85@genomewanderer.onmicrosoft.com::053b86ea-6602-4ddc-8908-2155e60e337f" providerId="AD" clId="Web-{24D326B1-2337-4274-BE59-5622B006B2B3}"/>
    <pc:docChg chg="modSld">
      <pc:chgData name="황미영" userId="S::myhwang85@genomewanderer.onmicrosoft.com::053b86ea-6602-4ddc-8908-2155e60e337f" providerId="AD" clId="Web-{24D326B1-2337-4274-BE59-5622B006B2B3}" dt="2022-07-07T01:53:17.489" v="11" actId="1076"/>
      <pc:docMkLst>
        <pc:docMk/>
      </pc:docMkLst>
      <pc:sldChg chg="addSp delSp modSp">
        <pc:chgData name="황미영" userId="S::myhwang85@genomewanderer.onmicrosoft.com::053b86ea-6602-4ddc-8908-2155e60e337f" providerId="AD" clId="Web-{24D326B1-2337-4274-BE59-5622B006B2B3}" dt="2022-07-07T01:53:17.489" v="11" actId="1076"/>
        <pc:sldMkLst>
          <pc:docMk/>
          <pc:sldMk cId="945405609" sldId="261"/>
        </pc:sldMkLst>
        <pc:picChg chg="add mod">
          <ac:chgData name="황미영" userId="S::myhwang85@genomewanderer.onmicrosoft.com::053b86ea-6602-4ddc-8908-2155e60e337f" providerId="AD" clId="Web-{24D326B1-2337-4274-BE59-5622B006B2B3}" dt="2022-07-07T01:53:17.489" v="11" actId="1076"/>
          <ac:picMkLst>
            <pc:docMk/>
            <pc:sldMk cId="945405609" sldId="261"/>
            <ac:picMk id="2" creationId="{6D41B358-B9B4-3806-3CDB-1C35FAAB7448}"/>
          </ac:picMkLst>
        </pc:picChg>
        <pc:picChg chg="del">
          <ac:chgData name="황미영" userId="S::myhwang85@genomewanderer.onmicrosoft.com::053b86ea-6602-4ddc-8908-2155e60e337f" providerId="AD" clId="Web-{24D326B1-2337-4274-BE59-5622B006B2B3}" dt="2022-07-07T01:51:48.440" v="0"/>
          <ac:picMkLst>
            <pc:docMk/>
            <pc:sldMk cId="945405609" sldId="261"/>
            <ac:picMk id="5" creationId="{4308A24C-F4CE-3CFE-36AC-671103395A1C}"/>
          </ac:picMkLst>
        </pc:picChg>
      </pc:sldChg>
      <pc:sldChg chg="addSp delSp modSp">
        <pc:chgData name="황미영" userId="S::myhwang85@genomewanderer.onmicrosoft.com::053b86ea-6602-4ddc-8908-2155e60e337f" providerId="AD" clId="Web-{24D326B1-2337-4274-BE59-5622B006B2B3}" dt="2022-07-07T01:53:10.239" v="10" actId="1076"/>
        <pc:sldMkLst>
          <pc:docMk/>
          <pc:sldMk cId="3148639263" sldId="262"/>
        </pc:sldMkLst>
        <pc:picChg chg="add mod">
          <ac:chgData name="황미영" userId="S::myhwang85@genomewanderer.onmicrosoft.com::053b86ea-6602-4ddc-8908-2155e60e337f" providerId="AD" clId="Web-{24D326B1-2337-4274-BE59-5622B006B2B3}" dt="2022-07-07T01:53:10.239" v="10" actId="1076"/>
          <ac:picMkLst>
            <pc:docMk/>
            <pc:sldMk cId="3148639263" sldId="262"/>
            <ac:picMk id="3" creationId="{696D0C94-9C0F-B348-F640-0F46129C92DF}"/>
          </ac:picMkLst>
        </pc:picChg>
        <pc:picChg chg="del">
          <ac:chgData name="황미영" userId="S::myhwang85@genomewanderer.onmicrosoft.com::053b86ea-6602-4ddc-8908-2155e60e337f" providerId="AD" clId="Web-{24D326B1-2337-4274-BE59-5622B006B2B3}" dt="2022-07-07T01:52:39.254" v="5"/>
          <ac:picMkLst>
            <pc:docMk/>
            <pc:sldMk cId="3148639263" sldId="262"/>
            <ac:picMk id="6" creationId="{BEBF686B-5135-A5DE-EE23-B102CA4FB16F}"/>
          </ac:picMkLst>
        </pc:picChg>
      </pc:sldChg>
    </pc:docChg>
  </pc:docChgLst>
  <pc:docChgLst>
    <pc:chgData name="황미영" userId="S::myhwang85@genomewanderer.onmicrosoft.com::053b86ea-6602-4ddc-8908-2155e60e337f" providerId="AD" clId="Web-{AA6FAF9A-D400-486E-B2A7-23FA94FC5542}"/>
    <pc:docChg chg="modSld">
      <pc:chgData name="황미영" userId="S::myhwang85@genomewanderer.onmicrosoft.com::053b86ea-6602-4ddc-8908-2155e60e337f" providerId="AD" clId="Web-{AA6FAF9A-D400-486E-B2A7-23FA94FC5542}" dt="2022-07-08T01:32:50.334" v="13"/>
      <pc:docMkLst>
        <pc:docMk/>
      </pc:docMkLst>
      <pc:sldChg chg="addSp delSp modSp">
        <pc:chgData name="황미영" userId="S::myhwang85@genomewanderer.onmicrosoft.com::053b86ea-6602-4ddc-8908-2155e60e337f" providerId="AD" clId="Web-{AA6FAF9A-D400-486E-B2A7-23FA94FC5542}" dt="2022-07-08T01:32:50.334" v="13"/>
        <pc:sldMkLst>
          <pc:docMk/>
          <pc:sldMk cId="3472007779" sldId="256"/>
        </pc:sldMkLst>
        <pc:spChg chg="add del mod">
          <ac:chgData name="황미영" userId="S::myhwang85@genomewanderer.onmicrosoft.com::053b86ea-6602-4ddc-8908-2155e60e337f" providerId="AD" clId="Web-{AA6FAF9A-D400-486E-B2A7-23FA94FC5542}" dt="2022-07-08T01:32:50.334" v="13"/>
          <ac:spMkLst>
            <pc:docMk/>
            <pc:sldMk cId="3472007779" sldId="256"/>
            <ac:spMk id="2" creationId="{4DE956F4-86DA-1715-DEC7-65F36B244D8D}"/>
          </ac:spMkLst>
        </pc:spChg>
        <pc:spChg chg="mod">
          <ac:chgData name="황미영" userId="S::myhwang85@genomewanderer.onmicrosoft.com::053b86ea-6602-4ddc-8908-2155e60e337f" providerId="AD" clId="Web-{AA6FAF9A-D400-486E-B2A7-23FA94FC5542}" dt="2022-07-08T01:32:35.209" v="9" actId="20577"/>
          <ac:spMkLst>
            <pc:docMk/>
            <pc:sldMk cId="3472007779" sldId="256"/>
            <ac:spMk id="8" creationId="{8FC17538-ABFC-4B12-D190-0F5CD23C7444}"/>
          </ac:spMkLst>
        </pc:spChg>
        <pc:spChg chg="mod">
          <ac:chgData name="황미영" userId="S::myhwang85@genomewanderer.onmicrosoft.com::053b86ea-6602-4ddc-8908-2155e60e337f" providerId="AD" clId="Web-{AA6FAF9A-D400-486E-B2A7-23FA94FC5542}" dt="2022-07-08T01:32:38.459" v="11" actId="20577"/>
          <ac:spMkLst>
            <pc:docMk/>
            <pc:sldMk cId="3472007779" sldId="256"/>
            <ac:spMk id="17" creationId="{9E95BBAE-8F7E-B900-59E1-FE30AF54E998}"/>
          </ac:spMkLst>
        </pc:spChg>
      </pc:sldChg>
    </pc:docChg>
  </pc:docChgLst>
  <pc:docChgLst>
    <pc:chgData name="황미영" userId="S::myhwang85@genomewanderer.onmicrosoft.com::053b86ea-6602-4ddc-8908-2155e60e337f" providerId="AD" clId="Web-{4473A940-9468-4EB7-A44C-70C1191C90E6}"/>
    <pc:docChg chg="modSld">
      <pc:chgData name="황미영" userId="S::myhwang85@genomewanderer.onmicrosoft.com::053b86ea-6602-4ddc-8908-2155e60e337f" providerId="AD" clId="Web-{4473A940-9468-4EB7-A44C-70C1191C90E6}" dt="2022-07-06T14:05:47.224" v="23" actId="1076"/>
      <pc:docMkLst>
        <pc:docMk/>
      </pc:docMkLst>
      <pc:sldChg chg="addSp delSp modSp">
        <pc:chgData name="황미영" userId="S::myhwang85@genomewanderer.onmicrosoft.com::053b86ea-6602-4ddc-8908-2155e60e337f" providerId="AD" clId="Web-{4473A940-9468-4EB7-A44C-70C1191C90E6}" dt="2022-07-06T14:05:09.504" v="17" actId="1076"/>
        <pc:sldMkLst>
          <pc:docMk/>
          <pc:sldMk cId="945405609" sldId="261"/>
        </pc:sldMkLst>
        <pc:picChg chg="del">
          <ac:chgData name="황미영" userId="S::myhwang85@genomewanderer.onmicrosoft.com::053b86ea-6602-4ddc-8908-2155e60e337f" providerId="AD" clId="Web-{4473A940-9468-4EB7-A44C-70C1191C90E6}" dt="2022-07-06T14:01:53.559" v="0"/>
          <ac:picMkLst>
            <pc:docMk/>
            <pc:sldMk cId="945405609" sldId="261"/>
            <ac:picMk id="2" creationId="{231B2E1F-FF28-C2E4-4815-6AA0E64A4A02}"/>
          </ac:picMkLst>
        </pc:picChg>
        <pc:picChg chg="add del mod">
          <ac:chgData name="황미영" userId="S::myhwang85@genomewanderer.onmicrosoft.com::053b86ea-6602-4ddc-8908-2155e60e337f" providerId="AD" clId="Web-{4473A940-9468-4EB7-A44C-70C1191C90E6}" dt="2022-07-06T14:04:40.644" v="12"/>
          <ac:picMkLst>
            <pc:docMk/>
            <pc:sldMk cId="945405609" sldId="261"/>
            <ac:picMk id="3" creationId="{99C9EA4A-1C20-C1DF-ABF5-3E92406C7FCB}"/>
          </ac:picMkLst>
        </pc:picChg>
        <pc:picChg chg="add mod">
          <ac:chgData name="황미영" userId="S::myhwang85@genomewanderer.onmicrosoft.com::053b86ea-6602-4ddc-8908-2155e60e337f" providerId="AD" clId="Web-{4473A940-9468-4EB7-A44C-70C1191C90E6}" dt="2022-07-06T14:05:09.504" v="17" actId="1076"/>
          <ac:picMkLst>
            <pc:docMk/>
            <pc:sldMk cId="945405609" sldId="261"/>
            <ac:picMk id="5" creationId="{4308A24C-F4CE-3CFE-36AC-671103395A1C}"/>
          </ac:picMkLst>
        </pc:picChg>
      </pc:sldChg>
      <pc:sldChg chg="addSp delSp modSp">
        <pc:chgData name="황미영" userId="S::myhwang85@genomewanderer.onmicrosoft.com::053b86ea-6602-4ddc-8908-2155e60e337f" providerId="AD" clId="Web-{4473A940-9468-4EB7-A44C-70C1191C90E6}" dt="2022-07-06T14:05:47.224" v="23" actId="1076"/>
        <pc:sldMkLst>
          <pc:docMk/>
          <pc:sldMk cId="3148639263" sldId="262"/>
        </pc:sldMkLst>
        <pc:picChg chg="del">
          <ac:chgData name="황미영" userId="S::myhwang85@genomewanderer.onmicrosoft.com::053b86ea-6602-4ddc-8908-2155e60e337f" providerId="AD" clId="Web-{4473A940-9468-4EB7-A44C-70C1191C90E6}" dt="2022-07-06T14:02:45.655" v="6"/>
          <ac:picMkLst>
            <pc:docMk/>
            <pc:sldMk cId="3148639263" sldId="262"/>
            <ac:picMk id="3" creationId="{55C009AA-1EDC-1144-B9DE-F8DE6782C16D}"/>
          </ac:picMkLst>
        </pc:picChg>
        <pc:picChg chg="add del mod">
          <ac:chgData name="황미영" userId="S::myhwang85@genomewanderer.onmicrosoft.com::053b86ea-6602-4ddc-8908-2155e60e337f" providerId="AD" clId="Web-{4473A940-9468-4EB7-A44C-70C1191C90E6}" dt="2022-07-06T14:05:25.755" v="18"/>
          <ac:picMkLst>
            <pc:docMk/>
            <pc:sldMk cId="3148639263" sldId="262"/>
            <ac:picMk id="5" creationId="{99FB40E8-8B30-6B12-7F26-FE0FF1DF50BC}"/>
          </ac:picMkLst>
        </pc:picChg>
        <pc:picChg chg="add mod">
          <ac:chgData name="황미영" userId="S::myhwang85@genomewanderer.onmicrosoft.com::053b86ea-6602-4ddc-8908-2155e60e337f" providerId="AD" clId="Web-{4473A940-9468-4EB7-A44C-70C1191C90E6}" dt="2022-07-06T14:05:47.224" v="23" actId="1076"/>
          <ac:picMkLst>
            <pc:docMk/>
            <pc:sldMk cId="3148639263" sldId="262"/>
            <ac:picMk id="6" creationId="{BEBF686B-5135-A5DE-EE23-B102CA4FB16F}"/>
          </ac:picMkLst>
        </pc:picChg>
      </pc:sldChg>
    </pc:docChg>
  </pc:docChgLst>
  <pc:docChgLst>
    <pc:chgData name="황미영" userId="S::myhwang85@genomewanderer.onmicrosoft.com::053b86ea-6602-4ddc-8908-2155e60e337f" providerId="AD" clId="Web-{0EB4A466-C6DB-467A-B0ED-C8B07A2BA4E7}"/>
    <pc:docChg chg="modSld">
      <pc:chgData name="황미영" userId="S::myhwang85@genomewanderer.onmicrosoft.com::053b86ea-6602-4ddc-8908-2155e60e337f" providerId="AD" clId="Web-{0EB4A466-C6DB-467A-B0ED-C8B07A2BA4E7}" dt="2022-07-06T13:53:36.237" v="19" actId="1076"/>
      <pc:docMkLst>
        <pc:docMk/>
      </pc:docMkLst>
      <pc:sldChg chg="addSp modSp">
        <pc:chgData name="황미영" userId="S::myhwang85@genomewanderer.onmicrosoft.com::053b86ea-6602-4ddc-8908-2155e60e337f" providerId="AD" clId="Web-{0EB4A466-C6DB-467A-B0ED-C8B07A2BA4E7}" dt="2022-07-06T13:52:27.298" v="7" actId="1076"/>
        <pc:sldMkLst>
          <pc:docMk/>
          <pc:sldMk cId="945405609" sldId="261"/>
        </pc:sldMkLst>
        <pc:picChg chg="add mod">
          <ac:chgData name="황미영" userId="S::myhwang85@genomewanderer.onmicrosoft.com::053b86ea-6602-4ddc-8908-2155e60e337f" providerId="AD" clId="Web-{0EB4A466-C6DB-467A-B0ED-C8B07A2BA4E7}" dt="2022-07-06T13:52:27.298" v="7" actId="1076"/>
          <ac:picMkLst>
            <pc:docMk/>
            <pc:sldMk cId="945405609" sldId="261"/>
            <ac:picMk id="2" creationId="{231B2E1F-FF28-C2E4-4815-6AA0E64A4A02}"/>
          </ac:picMkLst>
        </pc:picChg>
        <pc:picChg chg="mod">
          <ac:chgData name="황미영" userId="S::myhwang85@genomewanderer.onmicrosoft.com::053b86ea-6602-4ddc-8908-2155e60e337f" providerId="AD" clId="Web-{0EB4A466-C6DB-467A-B0ED-C8B07A2BA4E7}" dt="2022-07-06T13:51:36.279" v="0" actId="1076"/>
          <ac:picMkLst>
            <pc:docMk/>
            <pc:sldMk cId="945405609" sldId="261"/>
            <ac:picMk id="6" creationId="{D7B094E3-4ACE-7F4B-B5A5-176A66C5E80A}"/>
          </ac:picMkLst>
        </pc:picChg>
      </pc:sldChg>
      <pc:sldChg chg="addSp modSp">
        <pc:chgData name="황미영" userId="S::myhwang85@genomewanderer.onmicrosoft.com::053b86ea-6602-4ddc-8908-2155e60e337f" providerId="AD" clId="Web-{0EB4A466-C6DB-467A-B0ED-C8B07A2BA4E7}" dt="2022-07-06T13:53:36.237" v="19" actId="1076"/>
        <pc:sldMkLst>
          <pc:docMk/>
          <pc:sldMk cId="3148639263" sldId="262"/>
        </pc:sldMkLst>
        <pc:picChg chg="add mod">
          <ac:chgData name="황미영" userId="S::myhwang85@genomewanderer.onmicrosoft.com::053b86ea-6602-4ddc-8908-2155e60e337f" providerId="AD" clId="Web-{0EB4A466-C6DB-467A-B0ED-C8B07A2BA4E7}" dt="2022-07-06T13:53:25.940" v="17" actId="1076"/>
          <ac:picMkLst>
            <pc:docMk/>
            <pc:sldMk cId="3148639263" sldId="262"/>
            <ac:picMk id="2" creationId="{378954C9-6DD0-A4A4-3D0A-F835730BEDB9}"/>
          </ac:picMkLst>
        </pc:picChg>
        <pc:picChg chg="add mod">
          <ac:chgData name="황미영" userId="S::myhwang85@genomewanderer.onmicrosoft.com::053b86ea-6602-4ddc-8908-2155e60e337f" providerId="AD" clId="Web-{0EB4A466-C6DB-467A-B0ED-C8B07A2BA4E7}" dt="2022-07-06T13:53:36.237" v="19" actId="1076"/>
          <ac:picMkLst>
            <pc:docMk/>
            <pc:sldMk cId="3148639263" sldId="262"/>
            <ac:picMk id="3" creationId="{55C009AA-1EDC-1144-B9DE-F8DE6782C16D}"/>
          </ac:picMkLst>
        </pc:picChg>
      </pc:sldChg>
    </pc:docChg>
  </pc:docChgLst>
  <pc:docChgLst>
    <pc:chgData name="황미영" userId="S::myhwang85@genomewanderer.onmicrosoft.com::053b86ea-6602-4ddc-8908-2155e60e337f" providerId="AD" clId="Web-{A2FE8121-67BB-432F-AD11-861EAA644E4F}"/>
    <pc:docChg chg="addSld modSld">
      <pc:chgData name="황미영" userId="S::myhwang85@genomewanderer.onmicrosoft.com::053b86ea-6602-4ddc-8908-2155e60e337f" providerId="AD" clId="Web-{A2FE8121-67BB-432F-AD11-861EAA644E4F}" dt="2022-07-06T13:32:09.721" v="112" actId="1076"/>
      <pc:docMkLst>
        <pc:docMk/>
      </pc:docMkLst>
      <pc:sldChg chg="addSp delSp modSp">
        <pc:chgData name="황미영" userId="S::myhwang85@genomewanderer.onmicrosoft.com::053b86ea-6602-4ddc-8908-2155e60e337f" providerId="AD" clId="Web-{A2FE8121-67BB-432F-AD11-861EAA644E4F}" dt="2022-07-06T13:30:45.344" v="92" actId="1076"/>
        <pc:sldMkLst>
          <pc:docMk/>
          <pc:sldMk cId="121120902" sldId="263"/>
        </pc:sldMkLst>
        <pc:spChg chg="mod">
          <ac:chgData name="황미영" userId="S::myhwang85@genomewanderer.onmicrosoft.com::053b86ea-6602-4ddc-8908-2155e60e337f" providerId="AD" clId="Web-{A2FE8121-67BB-432F-AD11-861EAA644E4F}" dt="2022-07-06T13:23:46.067" v="21" actId="20577"/>
          <ac:spMkLst>
            <pc:docMk/>
            <pc:sldMk cId="121120902" sldId="263"/>
            <ac:spMk id="4" creationId="{F15E1920-73D3-9C60-1E30-EA199990C894}"/>
          </ac:spMkLst>
        </pc:spChg>
        <pc:picChg chg="add del mod">
          <ac:chgData name="황미영" userId="S::myhwang85@genomewanderer.onmicrosoft.com::053b86ea-6602-4ddc-8908-2155e60e337f" providerId="AD" clId="Web-{A2FE8121-67BB-432F-AD11-861EAA644E4F}" dt="2022-07-06T13:24:13.161" v="25"/>
          <ac:picMkLst>
            <pc:docMk/>
            <pc:sldMk cId="121120902" sldId="263"/>
            <ac:picMk id="2" creationId="{49F9770C-8D81-61F4-C67F-6437FB784DA8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6:40.134" v="59"/>
          <ac:picMkLst>
            <pc:docMk/>
            <pc:sldMk cId="121120902" sldId="263"/>
            <ac:picMk id="3" creationId="{3098221B-66AF-90A5-D2E5-D0295B2C9A1D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6:39.431" v="58"/>
          <ac:picMkLst>
            <pc:docMk/>
            <pc:sldMk cId="121120902" sldId="263"/>
            <ac:picMk id="5" creationId="{A9F4122E-05C5-3192-7FB2-AF6EB2D9BB21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6:38.759" v="57"/>
          <ac:picMkLst>
            <pc:docMk/>
            <pc:sldMk cId="121120902" sldId="263"/>
            <ac:picMk id="6" creationId="{D8C1E6C2-A900-28C0-68E8-ECEDF4C4B3ED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9:57.249" v="78"/>
          <ac:picMkLst>
            <pc:docMk/>
            <pc:sldMk cId="121120902" sldId="263"/>
            <ac:picMk id="7" creationId="{2E257590-6A53-FFAD-46F6-AB8815D880ED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9:57.249" v="77"/>
          <ac:picMkLst>
            <pc:docMk/>
            <pc:sldMk cId="121120902" sldId="263"/>
            <ac:picMk id="8" creationId="{443A8798-03F6-6144-C0D3-D34E08BD1A18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9:57.249" v="76"/>
          <ac:picMkLst>
            <pc:docMk/>
            <pc:sldMk cId="121120902" sldId="263"/>
            <ac:picMk id="9" creationId="{F6180B46-013C-7510-E8ED-81B32F198934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5:52.851" v="44"/>
          <ac:picMkLst>
            <pc:docMk/>
            <pc:sldMk cId="121120902" sldId="263"/>
            <ac:picMk id="10" creationId="{ACBAFA39-2A29-0807-AF8E-D1038918736C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29:57.249" v="75"/>
          <ac:picMkLst>
            <pc:docMk/>
            <pc:sldMk cId="121120902" sldId="263"/>
            <ac:picMk id="11" creationId="{BBFF54F7-3258-1284-D9B5-3F1F6BBE3DA6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0:45.344" v="92" actId="1076"/>
          <ac:picMkLst>
            <pc:docMk/>
            <pc:sldMk cId="121120902" sldId="263"/>
            <ac:picMk id="12" creationId="{65B37AFB-2B1F-AA4F-8882-21DC8B729D68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0:31.906" v="89" actId="1076"/>
          <ac:picMkLst>
            <pc:docMk/>
            <pc:sldMk cId="121120902" sldId="263"/>
            <ac:picMk id="13" creationId="{D4CC883B-808D-9301-198F-0998D1F38F92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0:26.952" v="88" actId="1076"/>
          <ac:picMkLst>
            <pc:docMk/>
            <pc:sldMk cId="121120902" sldId="263"/>
            <ac:picMk id="14" creationId="{AF85D707-5EA2-6FDE-D646-3D6E9164CC29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0:43.797" v="91" actId="1076"/>
          <ac:picMkLst>
            <pc:docMk/>
            <pc:sldMk cId="121120902" sldId="263"/>
            <ac:picMk id="15" creationId="{9B1FBFBE-0700-85BD-9EBD-7A4CAFF87D4C}"/>
          </ac:picMkLst>
        </pc:picChg>
      </pc:sldChg>
      <pc:sldChg chg="add replId">
        <pc:chgData name="황미영" userId="S::myhwang85@genomewanderer.onmicrosoft.com::053b86ea-6602-4ddc-8908-2155e60e337f" providerId="AD" clId="Web-{A2FE8121-67BB-432F-AD11-861EAA644E4F}" dt="2022-07-06T13:23:22.030" v="0"/>
        <pc:sldMkLst>
          <pc:docMk/>
          <pc:sldMk cId="4262157301" sldId="265"/>
        </pc:sldMkLst>
      </pc:sldChg>
      <pc:sldChg chg="addSp delSp modSp add replId">
        <pc:chgData name="황미영" userId="S::myhwang85@genomewanderer.onmicrosoft.com::053b86ea-6602-4ddc-8908-2155e60e337f" providerId="AD" clId="Web-{A2FE8121-67BB-432F-AD11-861EAA644E4F}" dt="2022-07-06T13:32:09.721" v="112" actId="1076"/>
        <pc:sldMkLst>
          <pc:docMk/>
          <pc:sldMk cId="2722636622" sldId="266"/>
        </pc:sldMkLst>
        <pc:spChg chg="mod">
          <ac:chgData name="황미영" userId="S::myhwang85@genomewanderer.onmicrosoft.com::053b86ea-6602-4ddc-8908-2155e60e337f" providerId="AD" clId="Web-{A2FE8121-67BB-432F-AD11-861EAA644E4F}" dt="2022-07-06T13:26:52.587" v="62" actId="20577"/>
          <ac:spMkLst>
            <pc:docMk/>
            <pc:sldMk cId="2722636622" sldId="266"/>
            <ac:spMk id="4" creationId="{F15E1920-73D3-9C60-1E30-EA199990C894}"/>
          </ac:spMkLst>
        </pc:spChg>
        <pc:picChg chg="add del mod">
          <ac:chgData name="황미영" userId="S::myhwang85@genomewanderer.onmicrosoft.com::053b86ea-6602-4ddc-8908-2155e60e337f" providerId="AD" clId="Web-{A2FE8121-67BB-432F-AD11-861EAA644E4F}" dt="2022-07-06T13:30:58.797" v="96"/>
          <ac:picMkLst>
            <pc:docMk/>
            <pc:sldMk cId="2722636622" sldId="266"/>
            <ac:picMk id="2" creationId="{00F0C1EB-6B39-F265-9D1D-994D3CB0A49D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9.962" v="54"/>
          <ac:picMkLst>
            <pc:docMk/>
            <pc:sldMk cId="2722636622" sldId="266"/>
            <ac:picMk id="3" creationId="{3098221B-66AF-90A5-D2E5-D0295B2C9A1D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9.009" v="53"/>
          <ac:picMkLst>
            <pc:docMk/>
            <pc:sldMk cId="2722636622" sldId="266"/>
            <ac:picMk id="5" creationId="{A9F4122E-05C5-3192-7FB2-AF6EB2D9BB21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6.774" v="52"/>
          <ac:picMkLst>
            <pc:docMk/>
            <pc:sldMk cId="2722636622" sldId="266"/>
            <ac:picMk id="6" creationId="{D8C1E6C2-A900-28C0-68E8-ECEDF4C4B3ED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5.055" v="51"/>
          <ac:picMkLst>
            <pc:docMk/>
            <pc:sldMk cId="2722636622" sldId="266"/>
            <ac:picMk id="7" creationId="{2E257590-6A53-FFAD-46F6-AB8815D880ED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5.055" v="50"/>
          <ac:picMkLst>
            <pc:docMk/>
            <pc:sldMk cId="2722636622" sldId="266"/>
            <ac:picMk id="8" creationId="{443A8798-03F6-6144-C0D3-D34E08BD1A18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5.055" v="49"/>
          <ac:picMkLst>
            <pc:docMk/>
            <pc:sldMk cId="2722636622" sldId="266"/>
            <ac:picMk id="9" creationId="{F6180B46-013C-7510-E8ED-81B32F198934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30:58.797" v="95"/>
          <ac:picMkLst>
            <pc:docMk/>
            <pc:sldMk cId="2722636622" sldId="266"/>
            <ac:picMk id="10" creationId="{127462F2-6D8C-118A-9C29-5749D474FADB}"/>
          </ac:picMkLst>
        </pc:picChg>
        <pc:picChg chg="del">
          <ac:chgData name="황미영" userId="S::myhwang85@genomewanderer.onmicrosoft.com::053b86ea-6602-4ddc-8908-2155e60e337f" providerId="AD" clId="Web-{A2FE8121-67BB-432F-AD11-861EAA644E4F}" dt="2022-07-06T13:26:25.055" v="48"/>
          <ac:picMkLst>
            <pc:docMk/>
            <pc:sldMk cId="2722636622" sldId="266"/>
            <ac:picMk id="11" creationId="{BBFF54F7-3258-1284-D9B5-3F1F6BBE3DA6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30:58.797" v="94"/>
          <ac:picMkLst>
            <pc:docMk/>
            <pc:sldMk cId="2722636622" sldId="266"/>
            <ac:picMk id="12" creationId="{DDA872F8-4AA5-3AF9-1422-2632BFBD22A9}"/>
          </ac:picMkLst>
        </pc:picChg>
        <pc:picChg chg="add del mod">
          <ac:chgData name="황미영" userId="S::myhwang85@genomewanderer.onmicrosoft.com::053b86ea-6602-4ddc-8908-2155e60e337f" providerId="AD" clId="Web-{A2FE8121-67BB-432F-AD11-861EAA644E4F}" dt="2022-07-06T13:30:58.797" v="93"/>
          <ac:picMkLst>
            <pc:docMk/>
            <pc:sldMk cId="2722636622" sldId="266"/>
            <ac:picMk id="13" creationId="{EA118575-B391-7949-6FAC-66CF7D5F1045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2:09.721" v="112" actId="1076"/>
          <ac:picMkLst>
            <pc:docMk/>
            <pc:sldMk cId="2722636622" sldId="266"/>
            <ac:picMk id="14" creationId="{D92ADAF6-5D7F-0C47-2013-5F126BAA61E2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1:33.970" v="108" actId="1076"/>
          <ac:picMkLst>
            <pc:docMk/>
            <pc:sldMk cId="2722636622" sldId="266"/>
            <ac:picMk id="15" creationId="{6443EDD1-E7F6-5CF7-CDB8-B44D551CD63C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1:32.157" v="107" actId="1076"/>
          <ac:picMkLst>
            <pc:docMk/>
            <pc:sldMk cId="2722636622" sldId="266"/>
            <ac:picMk id="16" creationId="{1144F08B-9232-DF35-F49E-A3F6F267EDEE}"/>
          </ac:picMkLst>
        </pc:picChg>
        <pc:picChg chg="add mod">
          <ac:chgData name="황미영" userId="S::myhwang85@genomewanderer.onmicrosoft.com::053b86ea-6602-4ddc-8908-2155e60e337f" providerId="AD" clId="Web-{A2FE8121-67BB-432F-AD11-861EAA644E4F}" dt="2022-07-06T13:31:57.455" v="111" actId="1076"/>
          <ac:picMkLst>
            <pc:docMk/>
            <pc:sldMk cId="2722636622" sldId="266"/>
            <ac:picMk id="17" creationId="{1ECB01C2-D61F-63BD-2E3B-BC96FDD3DC8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AADD5C-41FE-D101-67F0-20A5990279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81C3A16-AF5D-DA2B-01A5-B47655BDDD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59DDC20-F4A1-BFCF-38C4-9AAE064CE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5164EC-DF04-8CD8-B0AB-7E8EFD18C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220E033-49D8-1CA9-C7BB-63EF9A189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499199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7F4E44-9431-C9C6-770A-C20FC7416A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32B612B-BC40-F1D2-55A9-F863886D89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0572AD-BE8E-79FD-0170-59CDE6DBC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8BC080-A824-4E07-39D7-70BFCD2CC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2A0A6B2-73CC-622E-6C24-DE687C3FE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28006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F508B0F-3AA0-6DD1-3D72-7B44E3622A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46BD585-A7C2-6D22-BA77-4476DAE311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DDCBC8-7AA3-D0EF-34C7-C1EA87056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DAB28D6-1BE5-13DC-54FC-32D6BCE94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7B0EB32-E66B-2BB5-7CD9-3B7DDFCEF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659477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7F616C-A443-A345-FED0-D16849555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7097DE5-CB40-768B-F737-77A3523CC9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EA27FF7-5B57-C40D-A89D-10DBB1C22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A30610E-7D9D-7097-E663-4B91FC91C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BBCD48D-C090-C3AB-1EAC-E41D194BF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01393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77F370-A3A5-3248-E33B-E145B64AB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3A46EE0-DFBF-6199-586F-020962107E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BB21F4D-EFEA-0465-7277-D0F77FDE4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DC3716-F5C6-8B36-7C80-8DC23DB65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6DA21AA-0EDB-9B64-404B-3C92FFF71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666593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D11AB84-F859-0DAC-7EC0-38DBC699F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0D5BCD6-E6A4-00BB-3E54-2329FC15A6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FFFC169-0144-075C-C05B-31E62A67CF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5902FBE-5E66-E5EF-9FCB-11D9FB3A0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30A462C-C4A2-F551-ABE9-1EB927311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871765C-974C-6073-1168-B6F4A4B69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433665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A63C899-0518-FF8B-4484-1D0CFBFBE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97A86B0-FA0E-A991-FECE-FE06DCC423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A78403A-9D8D-9A4E-9C47-2A276AB0F4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6FC75FE-BABA-B775-BCC7-403ACB7E27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F3E92D4-E7E1-5471-5572-9376EBF861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1236900-851D-D8FE-1987-0F5316736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7D1FF88-3B7B-DFAC-E0C6-2B2BF36B2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0560660-844D-096A-A720-919C1C989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267051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C93371-B005-1703-902A-7EE642A82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9B81C9F-E88E-772E-268A-2D16F1E26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6DFA9D0-8E3D-2813-5A42-3C6AA7048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ECF9875-319B-8D50-FB2E-CB22EA6F2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52566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9EF0094-6A08-B5E4-3A0A-F0C3D8C16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6B2D4D0-D05A-C82D-8E4A-EB1D0D525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9DDC9A3-EA0F-25F7-4956-B1F83375B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959758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8EF85-FC8D-EE20-FB6B-4502F0C20A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E66903C-1DBA-3A35-1138-2E7D89EE6D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098F864-2C1A-D413-70DB-26F4F4D9A4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741CE5D-497F-D24B-680D-A43787E1B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D506035-E7CF-9D27-4445-AC61A5641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181C813-FC37-C89A-2D50-6A6B93B36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18033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9D05478-0332-F06D-2E61-298A71602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B1DC7EB-34D2-47CC-1E05-97DCE30B86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D832D5C-0624-C97B-D60F-44436A3084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703DFC-9E42-324E-815A-79CDA7C61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0BA590-67B6-36DD-7772-F15E946CA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99B3497-440B-185F-F222-6F851A345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72137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3791BCA-C2C1-21AC-96B5-A2A12ABD9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87C7EB8-2ACD-9442-96CB-1DEEA10E57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87F8FFD-4597-97BC-59CC-3352816E03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460A1-97A9-424F-AD51-47BF4EDA21A3}" type="datetimeFigureOut">
              <a:rPr kumimoji="1" lang="ko-KR" altLang="en-US" smtClean="0"/>
              <a:t>2022. 11. 1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C24C9F1-5C3F-732B-43A5-5BEC515625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0F38BBB-65D9-0066-EAB7-DBA1A8FFF9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9BD35-BD00-4744-AE29-5C58D45C804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142208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130">
            <a:extLst>
              <a:ext uri="{FF2B5EF4-FFF2-40B4-BE49-F238E27FC236}">
                <a16:creationId xmlns:a16="http://schemas.microsoft.com/office/drawing/2014/main" id="{154A3892-0447-E07B-3C1E-DBA0305FA29C}"/>
              </a:ext>
            </a:extLst>
          </p:cNvPr>
          <p:cNvSpPr/>
          <p:nvPr/>
        </p:nvSpPr>
        <p:spPr>
          <a:xfrm>
            <a:off x="4763729" y="4016489"/>
            <a:ext cx="7302249" cy="2428119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AD2A3861-25DE-5A6E-9057-82DBD1DBAA30}"/>
              </a:ext>
            </a:extLst>
          </p:cNvPr>
          <p:cNvSpPr/>
          <p:nvPr/>
        </p:nvSpPr>
        <p:spPr>
          <a:xfrm>
            <a:off x="179011" y="160423"/>
            <a:ext cx="4175497" cy="5955183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1EF79907-D3F6-4877-345A-F5487E9903F7}"/>
              </a:ext>
            </a:extLst>
          </p:cNvPr>
          <p:cNvSpPr/>
          <p:nvPr/>
        </p:nvSpPr>
        <p:spPr>
          <a:xfrm>
            <a:off x="4763729" y="171701"/>
            <a:ext cx="7302249" cy="3465070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D05D145-ABDD-0FDD-E84D-5AED29F3E5B2}"/>
              </a:ext>
            </a:extLst>
          </p:cNvPr>
          <p:cNvSpPr txBox="1"/>
          <p:nvPr/>
        </p:nvSpPr>
        <p:spPr>
          <a:xfrm>
            <a:off x="268182" y="6505676"/>
            <a:ext cx="78276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schematic representation of construction of KRG reference panel and imputation analysis</a:t>
            </a: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63D6DC2B-26B4-EDCB-00BB-48AC196C76D2}"/>
              </a:ext>
            </a:extLst>
          </p:cNvPr>
          <p:cNvSpPr/>
          <p:nvPr/>
        </p:nvSpPr>
        <p:spPr>
          <a:xfrm>
            <a:off x="562448" y="2845310"/>
            <a:ext cx="3402000" cy="872414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rate relative reports using KING v.2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 variants with missing rate &lt; 0.01, 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WE &lt; 1e-3, and MAF &lt; 0.1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,490 samples are un-related)</a:t>
            </a:r>
            <a:endParaRPr kumimoji="1" lang="en-US" altLang="ko-KR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모서리가 둥근 직사각형 3">
            <a:extLst>
              <a:ext uri="{FF2B5EF4-FFF2-40B4-BE49-F238E27FC236}">
                <a16:creationId xmlns:a16="http://schemas.microsoft.com/office/drawing/2014/main" id="{6237D0C7-669C-2F31-FBD8-4172F2E27801}"/>
              </a:ext>
            </a:extLst>
          </p:cNvPr>
          <p:cNvSpPr/>
          <p:nvPr/>
        </p:nvSpPr>
        <p:spPr>
          <a:xfrm>
            <a:off x="562448" y="675643"/>
            <a:ext cx="3402000" cy="605894"/>
          </a:xfrm>
          <a:prstGeom prst="round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G pilot dataset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GS joint-calling using DRAGEN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9,935,959 SNPs from 1,490 samples)</a:t>
            </a:r>
            <a:endParaRPr kumimoji="1" lang="ko-KR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6C56AA73-476C-0286-7920-BA16AE7C0518}"/>
              </a:ext>
            </a:extLst>
          </p:cNvPr>
          <p:cNvSpPr/>
          <p:nvPr/>
        </p:nvSpPr>
        <p:spPr>
          <a:xfrm>
            <a:off x="563637" y="5364569"/>
            <a:ext cx="3400811" cy="547200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rean Reference Genome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3,637,761 SNPs from 1,490 samples)</a:t>
            </a:r>
          </a:p>
        </p:txBody>
      </p:sp>
      <p:sp>
        <p:nvSpPr>
          <p:cNvPr id="13" name="모서리가 둥근 직사각형 12">
            <a:extLst>
              <a:ext uri="{FF2B5EF4-FFF2-40B4-BE49-F238E27FC236}">
                <a16:creationId xmlns:a16="http://schemas.microsoft.com/office/drawing/2014/main" id="{905E3DBD-74E7-7D90-B02D-C37BCFE0BCB7}"/>
              </a:ext>
            </a:extLst>
          </p:cNvPr>
          <p:cNvSpPr/>
          <p:nvPr/>
        </p:nvSpPr>
        <p:spPr>
          <a:xfrm>
            <a:off x="4929760" y="551420"/>
            <a:ext cx="3402000" cy="741600"/>
          </a:xfrm>
          <a:prstGeom prst="round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8 Korean WGS data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GS joint-calling variants using DRAGEN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08 KOR)</a:t>
            </a:r>
            <a:endParaRPr kumimoji="1" lang="ko-KR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32321F66-0A7B-CAEE-E927-4C46C3B66D3C}"/>
              </a:ext>
            </a:extLst>
          </p:cNvPr>
          <p:cNvSpPr/>
          <p:nvPr/>
        </p:nvSpPr>
        <p:spPr>
          <a:xfrm>
            <a:off x="6630759" y="1660783"/>
            <a:ext cx="3402000" cy="1075761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mulated datasets</a:t>
            </a:r>
          </a:p>
          <a:p>
            <a:pPr marL="171450" indent="-171450">
              <a:buFontTx/>
              <a:buChar char="-"/>
            </a:pP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 variants from WGS to make an artificial Korea Biobank Array (690,971 variants)</a:t>
            </a:r>
          </a:p>
          <a:p>
            <a:pPr marL="171450" indent="-171450">
              <a:buFontTx/>
              <a:buChar char="-"/>
            </a:pP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 variants from WGS to make an artificial UK Biobank Array (728,551 variants)</a:t>
            </a:r>
            <a:endParaRPr kumimoji="1" lang="en-US" altLang="ko-KR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모서리가 둥근 직사각형 16">
            <a:extLst>
              <a:ext uri="{FF2B5EF4-FFF2-40B4-BE49-F238E27FC236}">
                <a16:creationId xmlns:a16="http://schemas.microsoft.com/office/drawing/2014/main" id="{9E95BBAE-8F7E-B900-59E1-FE30AF54E998}"/>
              </a:ext>
            </a:extLst>
          </p:cNvPr>
          <p:cNvSpPr/>
          <p:nvPr/>
        </p:nvSpPr>
        <p:spPr>
          <a:xfrm>
            <a:off x="8521533" y="551420"/>
            <a:ext cx="3402000" cy="741600"/>
          </a:xfrm>
          <a:prstGeom prst="round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 Genome Project Phase 3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08 CH, 104 JPT, and 208 EUR)</a:t>
            </a:r>
            <a:endParaRPr kumimoji="1" lang="ko-KR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16749B3F-7155-9145-A446-8BB2D3A64AEB}"/>
              </a:ext>
            </a:extLst>
          </p:cNvPr>
          <p:cNvSpPr/>
          <p:nvPr/>
        </p:nvSpPr>
        <p:spPr>
          <a:xfrm>
            <a:off x="4929760" y="4701665"/>
            <a:ext cx="1559530" cy="589164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ute using KRG</a:t>
            </a:r>
          </a:p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inimac4, in-house)</a:t>
            </a:r>
            <a:endParaRPr kumimoji="1" lang="en-US" altLang="ko-KR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F40B1CF3-1150-5E10-AD10-C26C05F7BC1B}"/>
              </a:ext>
            </a:extLst>
          </p:cNvPr>
          <p:cNvSpPr/>
          <p:nvPr/>
        </p:nvSpPr>
        <p:spPr>
          <a:xfrm>
            <a:off x="6621977" y="4701665"/>
            <a:ext cx="1559530" cy="592083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ute using </a:t>
            </a:r>
            <a:r>
              <a:rPr kumimoji="1"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sP</a:t>
            </a:r>
            <a:endParaRPr kumimoji="1" lang="en-US" altLang="ko-KR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ichigan Server)</a:t>
            </a:r>
            <a:endParaRPr kumimoji="1" lang="en-US" altLang="ko-KR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B6D0CB49-4241-6B26-0489-9927C89BE268}"/>
              </a:ext>
            </a:extLst>
          </p:cNvPr>
          <p:cNvSpPr/>
          <p:nvPr/>
        </p:nvSpPr>
        <p:spPr>
          <a:xfrm>
            <a:off x="8314194" y="4701664"/>
            <a:ext cx="1559530" cy="589164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ute using </a:t>
            </a:r>
            <a:r>
              <a:rPr kumimoji="1"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naMAP</a:t>
            </a: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naMAP</a:t>
            </a: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rver)</a:t>
            </a:r>
            <a:endParaRPr kumimoji="1" lang="en-US" altLang="ko-KR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43F4435A-D5D0-22F3-2211-3F6C6D3A4557}"/>
              </a:ext>
            </a:extLst>
          </p:cNvPr>
          <p:cNvSpPr/>
          <p:nvPr/>
        </p:nvSpPr>
        <p:spPr>
          <a:xfrm>
            <a:off x="10006410" y="4701665"/>
            <a:ext cx="1559530" cy="589164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ute using </a:t>
            </a:r>
            <a:r>
              <a:rPr kumimoji="1"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Med</a:t>
            </a: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Med</a:t>
            </a:r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rver)</a:t>
            </a:r>
            <a:endParaRPr kumimoji="1" lang="en-US" altLang="ko-KR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E28AA12B-A83F-C19C-4CF0-6124A23228AB}"/>
              </a:ext>
            </a:extLst>
          </p:cNvPr>
          <p:cNvSpPr/>
          <p:nvPr/>
        </p:nvSpPr>
        <p:spPr>
          <a:xfrm>
            <a:off x="6630759" y="2957636"/>
            <a:ext cx="3402000" cy="544438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ing by simulated masked array datasets using eagle v2.3</a:t>
            </a:r>
            <a:endParaRPr kumimoji="1" lang="en-US" altLang="ko-KR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787D3D6A-A72C-9CD1-9101-96D37AFC370B}"/>
              </a:ext>
            </a:extLst>
          </p:cNvPr>
          <p:cNvCxnSpPr>
            <a:cxnSpLocks/>
            <a:stCxn id="4" idx="2"/>
            <a:endCxn id="12" idx="0"/>
          </p:cNvCxnSpPr>
          <p:nvPr/>
        </p:nvCxnSpPr>
        <p:spPr>
          <a:xfrm>
            <a:off x="2263448" y="1281537"/>
            <a:ext cx="0" cy="289246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45AED784-9EDD-37BF-1217-68DB252E1CCE}"/>
              </a:ext>
            </a:extLst>
          </p:cNvPr>
          <p:cNvCxnSpPr>
            <a:cxnSpLocks/>
            <a:stCxn id="15" idx="2"/>
            <a:endCxn id="22" idx="0"/>
          </p:cNvCxnSpPr>
          <p:nvPr/>
        </p:nvCxnSpPr>
        <p:spPr>
          <a:xfrm>
            <a:off x="8331759" y="2736544"/>
            <a:ext cx="0" cy="221092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꺾인 연결선[E] 35">
            <a:extLst>
              <a:ext uri="{FF2B5EF4-FFF2-40B4-BE49-F238E27FC236}">
                <a16:creationId xmlns:a16="http://schemas.microsoft.com/office/drawing/2014/main" id="{B51F62A1-FF0A-DB2A-3266-1348306273F0}"/>
              </a:ext>
            </a:extLst>
          </p:cNvPr>
          <p:cNvCxnSpPr>
            <a:cxnSpLocks/>
            <a:endCxn id="18" idx="0"/>
          </p:cNvCxnSpPr>
          <p:nvPr/>
        </p:nvCxnSpPr>
        <p:spPr>
          <a:xfrm>
            <a:off x="4341334" y="4454044"/>
            <a:ext cx="1368191" cy="247621"/>
          </a:xfrm>
          <a:prstGeom prst="bentConnector2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꺾인 연결선[E] 36">
            <a:extLst>
              <a:ext uri="{FF2B5EF4-FFF2-40B4-BE49-F238E27FC236}">
                <a16:creationId xmlns:a16="http://schemas.microsoft.com/office/drawing/2014/main" id="{FB31C479-8B1D-5A97-02A5-2A922FC3AB08}"/>
              </a:ext>
            </a:extLst>
          </p:cNvPr>
          <p:cNvCxnSpPr>
            <a:cxnSpLocks/>
            <a:stCxn id="17" idx="2"/>
          </p:cNvCxnSpPr>
          <p:nvPr/>
        </p:nvCxnSpPr>
        <p:spPr>
          <a:xfrm rot="5400000">
            <a:off x="9100707" y="524074"/>
            <a:ext cx="352880" cy="1890773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꺾인 연결선[E] 37">
            <a:extLst>
              <a:ext uri="{FF2B5EF4-FFF2-40B4-BE49-F238E27FC236}">
                <a16:creationId xmlns:a16="http://schemas.microsoft.com/office/drawing/2014/main" id="{A208D170-FC75-3316-45D1-E2DD2276CA6E}"/>
              </a:ext>
            </a:extLst>
          </p:cNvPr>
          <p:cNvCxnSpPr>
            <a:cxnSpLocks/>
            <a:stCxn id="22" idx="2"/>
            <a:endCxn id="19" idx="0"/>
          </p:cNvCxnSpPr>
          <p:nvPr/>
        </p:nvCxnSpPr>
        <p:spPr>
          <a:xfrm rot="5400000">
            <a:off x="7266956" y="3636861"/>
            <a:ext cx="1199591" cy="930017"/>
          </a:xfrm>
          <a:prstGeom prst="bentConnector3">
            <a:avLst>
              <a:gd name="adj1" fmla="val 62295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꺾인 연결선[E] 38">
            <a:extLst>
              <a:ext uri="{FF2B5EF4-FFF2-40B4-BE49-F238E27FC236}">
                <a16:creationId xmlns:a16="http://schemas.microsoft.com/office/drawing/2014/main" id="{B62B0FFB-0522-0504-7AA6-095720FEAB07}"/>
              </a:ext>
            </a:extLst>
          </p:cNvPr>
          <p:cNvCxnSpPr>
            <a:cxnSpLocks/>
            <a:stCxn id="13" idx="2"/>
          </p:cNvCxnSpPr>
          <p:nvPr/>
        </p:nvCxnSpPr>
        <p:spPr>
          <a:xfrm rot="16200000" flipH="1">
            <a:off x="7304820" y="618960"/>
            <a:ext cx="352880" cy="1701000"/>
          </a:xfrm>
          <a:prstGeom prst="bentConnector3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화살표 연결선 46">
            <a:extLst>
              <a:ext uri="{FF2B5EF4-FFF2-40B4-BE49-F238E27FC236}">
                <a16:creationId xmlns:a16="http://schemas.microsoft.com/office/drawing/2014/main" id="{6BA03511-389A-1AF5-2482-703AAE8DF36B}"/>
              </a:ext>
            </a:extLst>
          </p:cNvPr>
          <p:cNvCxnSpPr>
            <a:cxnSpLocks/>
            <a:endCxn id="20" idx="0"/>
          </p:cNvCxnSpPr>
          <p:nvPr/>
        </p:nvCxnSpPr>
        <p:spPr>
          <a:xfrm>
            <a:off x="9093957" y="4253563"/>
            <a:ext cx="2" cy="448101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꺾인 연결선[E] 49">
            <a:extLst>
              <a:ext uri="{FF2B5EF4-FFF2-40B4-BE49-F238E27FC236}">
                <a16:creationId xmlns:a16="http://schemas.microsoft.com/office/drawing/2014/main" id="{4D3EB381-625F-BE01-FCCC-C4A78AFBE5D6}"/>
              </a:ext>
            </a:extLst>
          </p:cNvPr>
          <p:cNvCxnSpPr>
            <a:cxnSpLocks/>
            <a:stCxn id="22" idx="2"/>
            <a:endCxn id="21" idx="0"/>
          </p:cNvCxnSpPr>
          <p:nvPr/>
        </p:nvCxnSpPr>
        <p:spPr>
          <a:xfrm rot="16200000" flipH="1">
            <a:off x="8959172" y="2874661"/>
            <a:ext cx="1199591" cy="2454416"/>
          </a:xfrm>
          <a:prstGeom prst="bentConnector3">
            <a:avLst>
              <a:gd name="adj1" fmla="val 62295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모서리가 둥근 직사각형 53">
            <a:extLst>
              <a:ext uri="{FF2B5EF4-FFF2-40B4-BE49-F238E27FC236}">
                <a16:creationId xmlns:a16="http://schemas.microsoft.com/office/drawing/2014/main" id="{25DA1EAA-84D9-2F64-C38E-2AC61BA91797}"/>
              </a:ext>
            </a:extLst>
          </p:cNvPr>
          <p:cNvSpPr/>
          <p:nvPr/>
        </p:nvSpPr>
        <p:spPr>
          <a:xfrm>
            <a:off x="4929760" y="5592679"/>
            <a:ext cx="6636180" cy="449187"/>
          </a:xfrm>
          <a:prstGeom prst="round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a-imputation using imputation results</a:t>
            </a:r>
          </a:p>
          <a:p>
            <a:pPr algn="ctr"/>
            <a:r>
              <a:rPr kumimoji="1"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ombining various combinations of reference panels)</a:t>
            </a:r>
            <a:endParaRPr kumimoji="1" lang="ko-KR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꺾인 연결선[E] 55">
            <a:extLst>
              <a:ext uri="{FF2B5EF4-FFF2-40B4-BE49-F238E27FC236}">
                <a16:creationId xmlns:a16="http://schemas.microsoft.com/office/drawing/2014/main" id="{E772B8A9-8A2F-B837-0A5C-D11B39BE90E7}"/>
              </a:ext>
            </a:extLst>
          </p:cNvPr>
          <p:cNvCxnSpPr>
            <a:cxnSpLocks/>
            <a:stCxn id="22" idx="2"/>
            <a:endCxn id="18" idx="0"/>
          </p:cNvCxnSpPr>
          <p:nvPr/>
        </p:nvCxnSpPr>
        <p:spPr>
          <a:xfrm rot="5400000">
            <a:off x="6420847" y="2790752"/>
            <a:ext cx="1199591" cy="2622234"/>
          </a:xfrm>
          <a:prstGeom prst="bentConnector3">
            <a:avLst>
              <a:gd name="adj1" fmla="val 62295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꺾인 연결선[E] 58">
            <a:extLst>
              <a:ext uri="{FF2B5EF4-FFF2-40B4-BE49-F238E27FC236}">
                <a16:creationId xmlns:a16="http://schemas.microsoft.com/office/drawing/2014/main" id="{B001A8EB-A969-F1D8-8F64-05E3368B2C4C}"/>
              </a:ext>
            </a:extLst>
          </p:cNvPr>
          <p:cNvCxnSpPr>
            <a:cxnSpLocks/>
            <a:stCxn id="19" idx="2"/>
            <a:endCxn id="54" idx="0"/>
          </p:cNvCxnSpPr>
          <p:nvPr/>
        </p:nvCxnSpPr>
        <p:spPr>
          <a:xfrm rot="16200000" flipH="1">
            <a:off x="7675331" y="5020159"/>
            <a:ext cx="298931" cy="846108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꺾인 연결선[E] 61">
            <a:extLst>
              <a:ext uri="{FF2B5EF4-FFF2-40B4-BE49-F238E27FC236}">
                <a16:creationId xmlns:a16="http://schemas.microsoft.com/office/drawing/2014/main" id="{B8923507-CC8F-72EE-F4C3-F7FAD4B84E67}"/>
              </a:ext>
            </a:extLst>
          </p:cNvPr>
          <p:cNvCxnSpPr>
            <a:cxnSpLocks/>
            <a:stCxn id="18" idx="2"/>
            <a:endCxn id="54" idx="0"/>
          </p:cNvCxnSpPr>
          <p:nvPr/>
        </p:nvCxnSpPr>
        <p:spPr>
          <a:xfrm rot="16200000" flipH="1">
            <a:off x="6827762" y="4172591"/>
            <a:ext cx="301850" cy="2538325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꺾인 연결선[E] 64">
            <a:extLst>
              <a:ext uri="{FF2B5EF4-FFF2-40B4-BE49-F238E27FC236}">
                <a16:creationId xmlns:a16="http://schemas.microsoft.com/office/drawing/2014/main" id="{EF8DEC41-D742-4331-B756-C721292B8981}"/>
              </a:ext>
            </a:extLst>
          </p:cNvPr>
          <p:cNvCxnSpPr>
            <a:cxnSpLocks/>
            <a:stCxn id="20" idx="2"/>
            <a:endCxn id="54" idx="0"/>
          </p:cNvCxnSpPr>
          <p:nvPr/>
        </p:nvCxnSpPr>
        <p:spPr>
          <a:xfrm rot="5400000">
            <a:off x="8519980" y="5018699"/>
            <a:ext cx="301851" cy="846109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꺾인 연결선[E] 67">
            <a:extLst>
              <a:ext uri="{FF2B5EF4-FFF2-40B4-BE49-F238E27FC236}">
                <a16:creationId xmlns:a16="http://schemas.microsoft.com/office/drawing/2014/main" id="{6B0B8A2D-2DE0-6328-0A67-AA802D4E62F3}"/>
              </a:ext>
            </a:extLst>
          </p:cNvPr>
          <p:cNvCxnSpPr>
            <a:cxnSpLocks/>
            <a:stCxn id="21" idx="2"/>
            <a:endCxn id="54" idx="0"/>
          </p:cNvCxnSpPr>
          <p:nvPr/>
        </p:nvCxnSpPr>
        <p:spPr>
          <a:xfrm rot="5400000">
            <a:off x="9366088" y="4172592"/>
            <a:ext cx="301850" cy="2538325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46428A78-A419-0457-8F99-A6D10D6A40EA}"/>
              </a:ext>
            </a:extLst>
          </p:cNvPr>
          <p:cNvSpPr txBox="1"/>
          <p:nvPr/>
        </p:nvSpPr>
        <p:spPr>
          <a:xfrm>
            <a:off x="2304905" y="5119180"/>
            <a:ext cx="172194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hasing using SHAPEIT4</a:t>
            </a:r>
            <a:endParaRPr kumimoji="1"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5AFACA0E-2651-5226-ABB8-DE126C059CB1}"/>
              </a:ext>
            </a:extLst>
          </p:cNvPr>
          <p:cNvSpPr/>
          <p:nvPr/>
        </p:nvSpPr>
        <p:spPr>
          <a:xfrm>
            <a:off x="562904" y="3991635"/>
            <a:ext cx="3401544" cy="1072301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sion criteria</a:t>
            </a:r>
          </a:p>
          <a:p>
            <a:r>
              <a:rPr kumimoji="1" lang="en-US" altLang="ko-K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s : </a:t>
            </a:r>
            <a:r>
              <a:rPr kumimoji="1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맑은 고딕"/>
                <a:cs typeface="Arial"/>
              </a:rPr>
              <a:t>missing rate &gt; 5%</a:t>
            </a:r>
          </a:p>
          <a:p>
            <a:r>
              <a:rPr kumimoji="1" lang="en-US" altLang="ko-K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Ps : </a:t>
            </a:r>
            <a:r>
              <a:rPr kumimoji="1" lang="en-US" altLang="ko-KR" sz="1000" dirty="0">
                <a:solidFill>
                  <a:schemeClr val="tx1"/>
                </a:solidFill>
                <a:latin typeface="Arial"/>
                <a:ea typeface="맑은 고딕"/>
                <a:cs typeface="Arial"/>
              </a:rPr>
              <a:t>HWE &lt; 1e-6, missing rate &gt; 5%, low complex regions, INDEL, &gt; 10  multiple  alternative alleles, AC = 1, 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/>
                <a:ea typeface="맑은 고딕"/>
                <a:cs typeface="Arial"/>
              </a:rPr>
              <a:t>available in &lt; 2 public databases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/>
                <a:ea typeface="맑은 고딕"/>
                <a:cs typeface="Arial"/>
              </a:rPr>
              <a:t>(13,637,761 SNPs pass QC from 1,490 samples)</a:t>
            </a:r>
          </a:p>
        </p:txBody>
      </p:sp>
      <p:cxnSp>
        <p:nvCxnSpPr>
          <p:cNvPr id="3" name="직선 화살표 연결선 2">
            <a:extLst>
              <a:ext uri="{FF2B5EF4-FFF2-40B4-BE49-F238E27FC236}">
                <a16:creationId xmlns:a16="http://schemas.microsoft.com/office/drawing/2014/main" id="{B14F1A7D-1D76-0E1B-7598-A65934C7F0F8}"/>
              </a:ext>
            </a:extLst>
          </p:cNvPr>
          <p:cNvCxnSpPr>
            <a:cxnSpLocks/>
            <a:stCxn id="2" idx="2"/>
            <a:endCxn id="10" idx="0"/>
          </p:cNvCxnSpPr>
          <p:nvPr/>
        </p:nvCxnSpPr>
        <p:spPr>
          <a:xfrm>
            <a:off x="2263676" y="5063936"/>
            <a:ext cx="367" cy="300633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id="{01934ACF-6EAD-6DF6-39A2-EE2F57A1711B}"/>
              </a:ext>
            </a:extLst>
          </p:cNvPr>
          <p:cNvCxnSpPr>
            <a:cxnSpLocks/>
            <a:stCxn id="5" idx="2"/>
            <a:endCxn id="2" idx="0"/>
          </p:cNvCxnSpPr>
          <p:nvPr/>
        </p:nvCxnSpPr>
        <p:spPr>
          <a:xfrm>
            <a:off x="2263448" y="3717724"/>
            <a:ext cx="228" cy="273911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57056E59-652B-B317-F924-CA6EF5A07C61}"/>
              </a:ext>
            </a:extLst>
          </p:cNvPr>
          <p:cNvSpPr/>
          <p:nvPr/>
        </p:nvSpPr>
        <p:spPr>
          <a:xfrm>
            <a:off x="562448" y="1570783"/>
            <a:ext cx="3402000" cy="1040646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kumimoji="1"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 VQSR criteria </a:t>
            </a:r>
          </a:p>
          <a:p>
            <a:pPr algn="ctr"/>
            <a:r>
              <a:rPr kumimoji="1" lang="en-US" altLang="ko-KR" sz="1000" dirty="0">
                <a:solidFill>
                  <a:schemeClr val="tx1"/>
                </a:solidFill>
                <a:latin typeface="Arial"/>
                <a:ea typeface="맑은 고딕"/>
                <a:cs typeface="Arial"/>
              </a:rPr>
              <a:t>if not marked as ‘PASS,’ ‘VQSRTrancheSNP99.90to100.00,’ or ‘VQSRTrancheINDEL99.90to100.00’</a:t>
            </a:r>
          </a:p>
          <a:p>
            <a:pPr algn="ctr"/>
            <a:r>
              <a:rPr lang="en-US" altLang="ko-KR" sz="1000" dirty="0">
                <a:solidFill>
                  <a:schemeClr val="tx1"/>
                </a:solidFill>
                <a:latin typeface="Arial"/>
                <a:ea typeface="맑은 고딕"/>
                <a:cs typeface="Arial"/>
              </a:rPr>
              <a:t>(29,059,286 variants from 1,490 samples)</a:t>
            </a:r>
          </a:p>
        </p:txBody>
      </p: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4861F1BA-99D6-D94D-2572-8957BB56F49D}"/>
              </a:ext>
            </a:extLst>
          </p:cNvPr>
          <p:cNvCxnSpPr>
            <a:cxnSpLocks/>
            <a:stCxn id="12" idx="2"/>
            <a:endCxn id="5" idx="0"/>
          </p:cNvCxnSpPr>
          <p:nvPr/>
        </p:nvCxnSpPr>
        <p:spPr>
          <a:xfrm>
            <a:off x="2263448" y="2611429"/>
            <a:ext cx="0" cy="233881"/>
          </a:xfrm>
          <a:prstGeom prst="straightConnector1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B653ADB7-A8A4-1E44-3156-98FA2117AD7D}"/>
              </a:ext>
            </a:extLst>
          </p:cNvPr>
          <p:cNvSpPr txBox="1"/>
          <p:nvPr/>
        </p:nvSpPr>
        <p:spPr>
          <a:xfrm>
            <a:off x="4732137" y="178680"/>
            <a:ext cx="517479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/>
              <a:t>&lt;Construction of Genotype panel&gt;</a:t>
            </a:r>
            <a:endParaRPr lang="en-KR" sz="1500" b="1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7C6C7B2-06FD-0E54-CA2C-FB0275EDF150}"/>
              </a:ext>
            </a:extLst>
          </p:cNvPr>
          <p:cNvSpPr txBox="1"/>
          <p:nvPr/>
        </p:nvSpPr>
        <p:spPr>
          <a:xfrm>
            <a:off x="268182" y="124263"/>
            <a:ext cx="517479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/>
              <a:t>&lt;Construction of KRG reference panel&gt;</a:t>
            </a:r>
            <a:endParaRPr lang="en-KR" sz="1500" b="1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362D0F0-E34B-C6DD-EA71-E731B6835D18}"/>
              </a:ext>
            </a:extLst>
          </p:cNvPr>
          <p:cNvSpPr txBox="1"/>
          <p:nvPr/>
        </p:nvSpPr>
        <p:spPr>
          <a:xfrm>
            <a:off x="4732137" y="6126750"/>
            <a:ext cx="517479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/>
              <a:t>&lt;Imputation analysis&gt;</a:t>
            </a:r>
            <a:endParaRPr lang="en-KR" sz="1500" b="1" dirty="0"/>
          </a:p>
        </p:txBody>
      </p:sp>
    </p:spTree>
    <p:extLst>
      <p:ext uri="{BB962C8B-B14F-4D97-AF65-F5344CB8AC3E}">
        <p14:creationId xmlns:p14="http://schemas.microsoft.com/office/powerpoint/2010/main" val="3065458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D8694DE-09C6-ABCE-3D30-1082269F4B8D}"/>
              </a:ext>
            </a:extLst>
          </p:cNvPr>
          <p:cNvSpPr txBox="1"/>
          <p:nvPr/>
        </p:nvSpPr>
        <p:spPr>
          <a:xfrm>
            <a:off x="236483" y="5490215"/>
            <a:ext cx="117190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Population genetic analyses on East Asians and Koreans. 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PCA analysis of East Asians (1KGP3 EAS) and Koreans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Estimation of an optimal number of subpopulations for Korean population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analysis of Korean samples. 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CDX, Chinese Dai in Xishuangbanna; CHB, Han Chinese in Beijing; CHS, Southern Han Chinese; JPT, Japanese in Tokyo; KHV,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h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Ho Chi Minh City; KOR, Korean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AB4C5A5-1A0D-FFF4-D34E-E010FE12EC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3527"/>
            <a:ext cx="4762500" cy="381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D86CBB8-67B1-548A-90D0-96BE26568D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64003" y="823527"/>
            <a:ext cx="3810000" cy="381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FDF0A87-1655-08F8-434A-BCE1CCAE608C}"/>
              </a:ext>
            </a:extLst>
          </p:cNvPr>
          <p:cNvSpPr txBox="1"/>
          <p:nvPr/>
        </p:nvSpPr>
        <p:spPr>
          <a:xfrm>
            <a:off x="641802" y="4722580"/>
            <a:ext cx="2993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CA analysis of East Asians and Korean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AE93C4B-0198-35A6-81A4-77C1E613B174}"/>
              </a:ext>
            </a:extLst>
          </p:cNvPr>
          <p:cNvSpPr txBox="1"/>
          <p:nvPr/>
        </p:nvSpPr>
        <p:spPr>
          <a:xfrm>
            <a:off x="6459003" y="472257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A86AE2-1430-E6A5-F545-E7EB937D4148}"/>
              </a:ext>
            </a:extLst>
          </p:cNvPr>
          <p:cNvSpPr txBox="1"/>
          <p:nvPr/>
        </p:nvSpPr>
        <p:spPr>
          <a:xfrm>
            <a:off x="10164330" y="472257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8FC4AF7-AF8C-58F5-9F6D-F5534CC31A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4003" y="912579"/>
            <a:ext cx="3810000" cy="381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0084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5E1920-73D3-9C60-1E30-EA199990C894}"/>
              </a:ext>
            </a:extLst>
          </p:cNvPr>
          <p:cNvSpPr txBox="1"/>
          <p:nvPr/>
        </p:nvSpPr>
        <p:spPr>
          <a:xfrm>
            <a:off x="465181" y="6042521"/>
            <a:ext cx="113655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greg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ased on combining reference and genotype panels mimicking the UKB. The aggreg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s were computed for the target sample of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Korean,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hinese,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Japanese, and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European populations. The x-axes indicate the non-reference allele frequencies. The y-axes represent the aggreg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the imputation results. Vertical dashed lines indicate standard deviations of aggreg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or each bin. Abbreviation: UKB, UK Biobank Array; KRG, Korean Reference Genome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naMAP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hina Metabolic Analytics Project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sP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meAsi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00K Project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PMed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Trans-Omics for Precision Medici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94063A-4B07-3392-E7EF-56A96D3E19D6}"/>
              </a:ext>
            </a:extLst>
          </p:cNvPr>
          <p:cNvSpPr txBox="1"/>
          <p:nvPr/>
        </p:nvSpPr>
        <p:spPr>
          <a:xfrm>
            <a:off x="7124821" y="5827803"/>
            <a:ext cx="1087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uropean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6BE812C-7463-4C86-96AD-D713C71B96DD}"/>
              </a:ext>
            </a:extLst>
          </p:cNvPr>
          <p:cNvSpPr txBox="1"/>
          <p:nvPr/>
        </p:nvSpPr>
        <p:spPr>
          <a:xfrm>
            <a:off x="4248828" y="5827803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Japanese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ABDA7281-CCE3-23FA-B09E-0805E79B09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1708" y="6056"/>
            <a:ext cx="2880000" cy="2880000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447ED96D-0CE4-582C-4642-7CD9455803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4813" y="6056"/>
            <a:ext cx="2880000" cy="2880000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8FA23AF3-5810-40CD-41D3-CAA4C5349F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21708" y="3010101"/>
            <a:ext cx="2880000" cy="288000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75A47920-C20F-E33A-D29B-9A492CA59E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40227" y="3010101"/>
            <a:ext cx="2880000" cy="288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B805676-7B90-F5B2-8AB6-D22958627AD6}"/>
              </a:ext>
            </a:extLst>
          </p:cNvPr>
          <p:cNvSpPr txBox="1"/>
          <p:nvPr/>
        </p:nvSpPr>
        <p:spPr>
          <a:xfrm>
            <a:off x="4228566" y="2839732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orean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3C492A4-037E-915B-5CFB-5D7A8619E23B}"/>
              </a:ext>
            </a:extLst>
          </p:cNvPr>
          <p:cNvSpPr txBox="1"/>
          <p:nvPr/>
        </p:nvSpPr>
        <p:spPr>
          <a:xfrm>
            <a:off x="7070896" y="2839732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inese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498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1E71254-56F9-18DC-C23E-F76F7C06E5C5}"/>
              </a:ext>
            </a:extLst>
          </p:cNvPr>
          <p:cNvSpPr txBox="1"/>
          <p:nvPr/>
        </p:nvSpPr>
        <p:spPr>
          <a:xfrm>
            <a:off x="602204" y="6027003"/>
            <a:ext cx="109875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cent of well-imputed variants, determined by combining reference and genotype panels mimicking the UKB. The % of well-imputed variants (estim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0.8) was computed for the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Korean,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hinese,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Japanese, and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European populations. The x-axes indicate the frequencies of non-reference alleles. The y-axes represent the % of well-imputed variants among the imputed results. Abbreviations: UKB, UK Biobank Array; KRG, Korean Reference Genome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naMAP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hina Metabolic Analytics Project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sP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meAsi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00K Project; </a:t>
            </a:r>
            <a:r>
              <a:rPr kumimoji="1" lang="en-US" altLang="ko-KR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PMed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Trans-Omics for Precision Medicin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EBA541-E317-AF3F-6AFA-CBC940A76467}"/>
              </a:ext>
            </a:extLst>
          </p:cNvPr>
          <p:cNvSpPr txBox="1"/>
          <p:nvPr/>
        </p:nvSpPr>
        <p:spPr>
          <a:xfrm>
            <a:off x="7090954" y="5839092"/>
            <a:ext cx="1087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uropean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5C16F6-A831-BF55-B367-E0919CF8ECAF}"/>
              </a:ext>
            </a:extLst>
          </p:cNvPr>
          <p:cNvSpPr txBox="1"/>
          <p:nvPr/>
        </p:nvSpPr>
        <p:spPr>
          <a:xfrm>
            <a:off x="4214961" y="5839092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Japanese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02428FFE-3CCC-D9F5-DE9A-8228E2C5C5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7236" y="12112"/>
            <a:ext cx="2880000" cy="28800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76359E65-5E40-E4E7-A5B2-FBE31D0FB1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4009" y="12112"/>
            <a:ext cx="2880000" cy="288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BD798F90-4FC1-F159-E91F-0553585E24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7236" y="3010383"/>
            <a:ext cx="2880000" cy="28800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98536B6E-8710-A85D-E209-5909C780C0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54009" y="3010383"/>
            <a:ext cx="2880000" cy="2880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3826BEE-E803-EDE5-B0CA-4B5B08A9A4E8}"/>
              </a:ext>
            </a:extLst>
          </p:cNvPr>
          <p:cNvSpPr txBox="1"/>
          <p:nvPr/>
        </p:nvSpPr>
        <p:spPr>
          <a:xfrm>
            <a:off x="4194699" y="2828443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orean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D144E4A-A634-7598-C297-140BFA1D5C95}"/>
              </a:ext>
            </a:extLst>
          </p:cNvPr>
          <p:cNvSpPr txBox="1"/>
          <p:nvPr/>
        </p:nvSpPr>
        <p:spPr>
          <a:xfrm>
            <a:off x="7037029" y="2828443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inese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7188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1E71254-56F9-18DC-C23E-F76F7C06E5C5}"/>
              </a:ext>
            </a:extLst>
          </p:cNvPr>
          <p:cNvSpPr txBox="1"/>
          <p:nvPr/>
        </p:nvSpPr>
        <p:spPr>
          <a:xfrm>
            <a:off x="510616" y="6227400"/>
            <a:ext cx="111707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Imputation quality in genetically variable regions between Koreans and Europeans. D</a:t>
            </a:r>
            <a:r>
              <a:rPr lang="en-US" altLang="ko-Kore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ifferences in imputation quality</a:t>
            </a:r>
            <a:r>
              <a:rPr lang="en-US" altLang="ko-Kore-KR" sz="12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en-US" altLang="ko-Kore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Aggregated R</a:t>
            </a:r>
            <a:r>
              <a:rPr lang="en-US" altLang="ko-Kore-KR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ore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(R</a:t>
            </a:r>
            <a:r>
              <a:rPr lang="en-US" altLang="ko-Kore-KR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ore-KR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KRG</a:t>
            </a:r>
            <a:r>
              <a:rPr lang="en-US" altLang="ko-Kore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– R</a:t>
            </a:r>
            <a:r>
              <a:rPr lang="en-US" altLang="ko-Kore-KR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ore-KR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TOPMed</a:t>
            </a:r>
            <a:r>
              <a:rPr lang="en-US" altLang="ko-Kore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) by bins of allele frequencies for regions with top 1% variation in LD between populations and remaining 99% of regions</a:t>
            </a:r>
            <a:r>
              <a:rPr lang="ko-Kore-KR" altLang="ko-Kore-K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ko-KR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1AB28FC5-EF9C-D48E-5523-B0BA0A67F3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5199" y="3174339"/>
            <a:ext cx="7650000" cy="306000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2FA3710A-4E83-00AE-CC69-8DE349F4DF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5200" y="200301"/>
            <a:ext cx="3824999" cy="306000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0710D0CD-F5A6-411D-4C6E-20EF9915AA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5999" y="200301"/>
            <a:ext cx="3825000" cy="30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84166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13E9AA89-90D2-C0C5-973C-A901201612B0}"/>
              </a:ext>
            </a:extLst>
          </p:cNvPr>
          <p:cNvSpPr txBox="1"/>
          <p:nvPr/>
        </p:nvSpPr>
        <p:spPr>
          <a:xfrm>
            <a:off x="575733" y="6256250"/>
            <a:ext cx="11301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formance of meta-imputation. Imputation quality metrics for the Korea (KOR) genotype panel mimicking UKB were measured;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ggreg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% of well-imputed variants (estim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0.8), and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number of imputed variants (estim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0.8), and (</a:t>
            </a:r>
            <a:r>
              <a:rPr kumimoji="1"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# of imputed variants (estimated r</a:t>
            </a:r>
            <a:r>
              <a:rPr kumimoji="1" lang="en-US" altLang="ko-KR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0.4)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33AB266-93B6-A401-CC53-5193EAE26143}"/>
              </a:ext>
            </a:extLst>
          </p:cNvPr>
          <p:cNvSpPr txBox="1"/>
          <p:nvPr/>
        </p:nvSpPr>
        <p:spPr>
          <a:xfrm>
            <a:off x="4070520" y="2828443"/>
            <a:ext cx="1365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ggregated R</a:t>
            </a:r>
            <a:r>
              <a:rPr kumimoji="1" lang="en-US" altLang="ko-Kore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ko-Kore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94D330-9B9B-D16A-FAA4-C1500B524086}"/>
              </a:ext>
            </a:extLst>
          </p:cNvPr>
          <p:cNvSpPr txBox="1"/>
          <p:nvPr/>
        </p:nvSpPr>
        <p:spPr>
          <a:xfrm>
            <a:off x="6400325" y="2838896"/>
            <a:ext cx="21130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% of well-imputed variants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3742E24-FC5F-793B-B13C-1AC5843494C4}"/>
              </a:ext>
            </a:extLst>
          </p:cNvPr>
          <p:cNvSpPr txBox="1"/>
          <p:nvPr/>
        </p:nvSpPr>
        <p:spPr>
          <a:xfrm>
            <a:off x="5962164" y="5881597"/>
            <a:ext cx="3371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Number of imputed variants (estimated r</a:t>
            </a:r>
            <a:r>
              <a:rPr kumimoji="1" lang="en-US" altLang="ko-Kore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0.4)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E184242-8F25-3CC6-0375-EB38598C972B}"/>
              </a:ext>
            </a:extLst>
          </p:cNvPr>
          <p:cNvSpPr txBox="1"/>
          <p:nvPr/>
        </p:nvSpPr>
        <p:spPr>
          <a:xfrm>
            <a:off x="2716686" y="5883508"/>
            <a:ext cx="3384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ko-Kore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Number of imputed variants (estimated r</a:t>
            </a:r>
            <a:r>
              <a:rPr kumimoji="1" lang="en-US" altLang="ko-Kore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ko-Kore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0.8)</a:t>
            </a:r>
            <a:endParaRPr kumimoji="1" lang="ko-Kore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A991BD7-9D1E-9AC7-0D53-94F32447AB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9765" y="0"/>
            <a:ext cx="2880000" cy="28800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ABEB28FD-0F6B-974B-A80D-C30161A135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16864" y="0"/>
            <a:ext cx="2880000" cy="28800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EDB90545-A854-2E35-B551-7F52E40454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9765" y="3077199"/>
            <a:ext cx="2880000" cy="2880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327FABF6-3F5F-DE72-C1CB-D1DE2B3580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16864" y="3077199"/>
            <a:ext cx="288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8639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C5C2159707B140419FF89F4ED2876FA4" ma:contentTypeVersion="15" ma:contentTypeDescription="새 문서를 만듭니다." ma:contentTypeScope="" ma:versionID="361917209ca5fea9aa65cdc8059398f9">
  <xsd:schema xmlns:xsd="http://www.w3.org/2001/XMLSchema" xmlns:xs="http://www.w3.org/2001/XMLSchema" xmlns:p="http://schemas.microsoft.com/office/2006/metadata/properties" xmlns:ns2="9feaef27-e119-4f65-9b89-09b0ad95454c" xmlns:ns3="a426cd97-c021-423f-86de-99dec85aad57" targetNamespace="http://schemas.microsoft.com/office/2006/metadata/properties" ma:root="true" ma:fieldsID="f1eeab848dd7e0fdbb9c08d712bfd23a" ns2:_="" ns3:_="">
    <xsd:import namespace="9feaef27-e119-4f65-9b89-09b0ad95454c"/>
    <xsd:import namespace="a426cd97-c021-423f-86de-99dec85aad57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lcf76f155ced4ddcb4097134ff3c332f" minOccurs="0"/>
                <xsd:element ref="ns2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feaef27-e119-4f65-9b89-09b0ad95454c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공유 대상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세부 정보 공유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1656969-371f-4f5f-9def-ed5f753c1970}" ma:internalName="TaxCatchAll" ma:showField="CatchAllData" ma:web="9feaef27-e119-4f65-9b89-09b0ad95454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426cd97-c021-423f-86de-99dec85aad5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이미지 태그" ma:readOnly="false" ma:fieldId="{5cf76f15-5ced-4ddc-b409-7134ff3c332f}" ma:taxonomyMulti="true" ma:sspId="d08ad915-9e8a-4db0-875a-f85f948b206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9feaef27-e119-4f65-9b89-09b0ad95454c" xsi:nil="true"/>
    <lcf76f155ced4ddcb4097134ff3c332f xmlns="a426cd97-c021-423f-86de-99dec85aad57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6ABC9A93-3F12-4182-9EE0-BAF1E419F301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99657FA-0218-4657-A7D8-1F2C4A92601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feaef27-e119-4f65-9b89-09b0ad95454c"/>
    <ds:schemaRef ds:uri="a426cd97-c021-423f-86de-99dec85aad5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3155B23-9788-4E50-9AE8-9E61422F102A}">
  <ds:schemaRefs>
    <ds:schemaRef ds:uri="http://schemas.microsoft.com/office/2006/metadata/properties"/>
    <ds:schemaRef ds:uri="http://schemas.microsoft.com/office/infopath/2007/PartnerControls"/>
    <ds:schemaRef ds:uri="9feaef27-e119-4f65-9b89-09b0ad95454c"/>
    <ds:schemaRef ds:uri="a426cd97-c021-423f-86de-99dec85aad57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49</TotalTime>
  <Words>799</Words>
  <Application>Microsoft Macintosh PowerPoint</Application>
  <PresentationFormat>와이드스크린</PresentationFormat>
  <Paragraphs>61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0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황미영</dc:creator>
  <cp:lastModifiedBy>황미영</cp:lastModifiedBy>
  <cp:revision>283</cp:revision>
  <dcterms:created xsi:type="dcterms:W3CDTF">2022-07-03T04:24:04Z</dcterms:created>
  <dcterms:modified xsi:type="dcterms:W3CDTF">2022-11-16T07:21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5C2159707B140419FF89F4ED2876FA4</vt:lpwstr>
  </property>
  <property fmtid="{D5CDD505-2E9C-101B-9397-08002B2CF9AE}" pid="3" name="MediaServiceImageTags">
    <vt:lpwstr/>
  </property>
</Properties>
</file>